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59F94A-76C1-4F31-A2D0-DFB6FEA651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361E62-6F24-4408-BAF9-03D92423EC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54C94-2785-4F2A-B3F2-9794A67CA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71E361-6105-4575-B783-BF9633B62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302535-2186-4509-9D26-2FEE3BB09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1815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05A63-28EF-41DD-A8D9-E198B8EED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C2E35F-F710-466C-983C-8473F6B026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EDC60E-126D-4C96-8A0C-15F12998B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A5C51B-3B18-40FD-8F78-E48968654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0AD187-61BB-4397-9426-A40032A82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8942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6A20CF-5718-4A42-A60E-B392D58A41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CC42F2-1A81-4FB0-A495-FBD6EAD328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F50800-7999-4083-9E99-6426963F1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A1B601-F4DC-497B-B3E6-78FB4C00C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0B62D3-84F1-4035-9A92-4225A11D2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158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32B76F-9015-47BA-A700-AE9EAE0762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280B96-BBDF-4663-B953-4FBFE32A0E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F662FD-99A1-482F-B0AD-78AF1AED0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75AD46-08AB-40F8-82B6-07AB1FB2E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AACB99-0E44-4FD5-9A9C-254327C84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7919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ABCD5-AAAC-4C91-B49C-2BD0FD150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0A4AB5-11CC-4561-8611-7B012FDC13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77CA0F-C304-413B-9AA7-D3B201C3F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9FECE6-9D80-43A1-A20D-32D12AFF5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45B451-0E6C-4B3B-9796-6A635CA83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819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0F32C-B99E-4327-80F2-B5AA6E1A40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E62449-648C-49C4-A914-3B8A241DB7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D3FCC2-E024-48F7-8A53-06EC2C5A9C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D078B9-1876-441E-92C4-E6CF611A2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12B391-3441-454E-A83B-3BD3CAFDE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7C8A48-9B08-4A93-BF65-88D8EB2A1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5398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F7F72-BAC0-49DD-B88E-AC471DCC3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2D1107-0320-44A0-9F60-E2C7C1112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2A73C-1517-4A52-9F9D-132307BD74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DDBC4F-0E81-432C-9F59-EEE94E6AA8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92B769-AC4B-48AE-87C6-A16BFD3CEC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E98E79-6753-4666-AE5A-6CB2C73ED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81B2F3-C8C7-4F16-BE03-B20A59F87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D850D1-D968-43CD-8AAA-4270F2B4D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9713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93802F-8955-4266-8879-5BFA1DE11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44D8A0-7DC5-44E3-8A19-169101BEE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E9D74C-F94B-4F4A-AFE9-B9692B399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300AD8-BAA2-44E2-BA7A-465CCB5D0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598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D78095-63E2-4FA8-B4BD-8D1DE6379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C4F72E-B2DB-4D57-94F1-C5796BFB2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13CEED-8BE9-44C4-AE49-94FACF114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71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76358-DC72-49BA-AAAD-E88A1C26D3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69868C-2E98-4FC8-A1D4-784821E819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D4D7B7-8856-4284-B4D0-6C2363D287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17838A-4E8D-4C7D-B669-2487E0D47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48956B-D286-4114-A5C9-BDAE31162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A68CB4-8FBC-4BBA-803C-4C0DC56E6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38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C9F8AE-ED57-4CB4-8B2F-CC720E1573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EEB8F8-5943-40E2-986D-DA4C313A30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166AF5-A45F-465D-A1B7-851CD4530F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C42C82-BE68-41D8-9CEB-9614F8E79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130CA6-2068-4612-A2A2-822E65882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FDFAF1-F178-480E-82B0-E0FEEBFA7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559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519E5-FCE5-47AF-9713-90A70BF04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6C7C22-28A4-4EC8-941E-92811A3C03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498AE6-BBB2-4FBA-B4BB-6F66EFB022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8C489-CE44-46A4-A79A-8CE9CAF0F7BA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22D74D-2D5A-4B51-B5BF-764AF410CE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1E78F-339F-4410-B2D0-373C80E63A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3686E-5379-42E3-B87D-16B70652DF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1923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56">
            <a:extLst>
              <a:ext uri="{FF2B5EF4-FFF2-40B4-BE49-F238E27FC236}">
                <a16:creationId xmlns:a16="http://schemas.microsoft.com/office/drawing/2014/main" id="{9AD8099A-0F4D-4035-9DDB-7C259E162EE7}"/>
              </a:ext>
            </a:extLst>
          </p:cNvPr>
          <p:cNvGrpSpPr/>
          <p:nvPr/>
        </p:nvGrpSpPr>
        <p:grpSpPr>
          <a:xfrm>
            <a:off x="2137334" y="1178155"/>
            <a:ext cx="7077003" cy="1680393"/>
            <a:chOff x="2221416" y="584504"/>
            <a:chExt cx="7077003" cy="168039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025FB31-5870-45FB-B36C-0E945E4502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49669"/>
            <a:stretch/>
          </p:blipFill>
          <p:spPr>
            <a:xfrm>
              <a:off x="2221416" y="584504"/>
              <a:ext cx="7077003" cy="168039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99E7F42-DAD4-4FE9-BA29-98D0A0B1C114}"/>
                </a:ext>
              </a:extLst>
            </p:cNvPr>
            <p:cNvSpPr txBox="1"/>
            <p:nvPr/>
          </p:nvSpPr>
          <p:spPr>
            <a:xfrm>
              <a:off x="2611881" y="143380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C100746-A649-492A-8CA1-2A1E7535C566}"/>
                </a:ext>
              </a:extLst>
            </p:cNvPr>
            <p:cNvSpPr txBox="1"/>
            <p:nvPr/>
          </p:nvSpPr>
          <p:spPr>
            <a:xfrm>
              <a:off x="2890673" y="140786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B7D8F6B-5D5E-4374-B25A-2DDD57621A58}"/>
                </a:ext>
              </a:extLst>
            </p:cNvPr>
            <p:cNvSpPr txBox="1"/>
            <p:nvPr/>
          </p:nvSpPr>
          <p:spPr>
            <a:xfrm>
              <a:off x="2944530" y="141600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EA3B243-07B4-432A-8139-A73A2739E3A8}"/>
                </a:ext>
              </a:extLst>
            </p:cNvPr>
            <p:cNvSpPr txBox="1"/>
            <p:nvPr/>
          </p:nvSpPr>
          <p:spPr>
            <a:xfrm>
              <a:off x="3098033" y="136591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FEFB374-EA9E-4B5D-A032-2BBC10BB0351}"/>
                </a:ext>
              </a:extLst>
            </p:cNvPr>
            <p:cNvSpPr txBox="1"/>
            <p:nvPr/>
          </p:nvSpPr>
          <p:spPr>
            <a:xfrm>
              <a:off x="3379042" y="129055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CCACE00-84A7-463D-B0B1-3E02199EF2FA}"/>
                </a:ext>
              </a:extLst>
            </p:cNvPr>
            <p:cNvSpPr txBox="1"/>
            <p:nvPr/>
          </p:nvSpPr>
          <p:spPr>
            <a:xfrm>
              <a:off x="3432559" y="126778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C25305D-3A3F-42F4-81A7-E3D1998F7689}"/>
                </a:ext>
              </a:extLst>
            </p:cNvPr>
            <p:cNvSpPr txBox="1"/>
            <p:nvPr/>
          </p:nvSpPr>
          <p:spPr>
            <a:xfrm>
              <a:off x="3546347" y="122471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6CE1DF7-3FEB-499C-AA00-2C8AC789DAA9}"/>
                </a:ext>
              </a:extLst>
            </p:cNvPr>
            <p:cNvSpPr txBox="1"/>
            <p:nvPr/>
          </p:nvSpPr>
          <p:spPr>
            <a:xfrm>
              <a:off x="3599719" y="117596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690DD07-83D0-4EE5-AF46-FE3EFB0DBB25}"/>
                </a:ext>
              </a:extLst>
            </p:cNvPr>
            <p:cNvSpPr txBox="1"/>
            <p:nvPr/>
          </p:nvSpPr>
          <p:spPr>
            <a:xfrm>
              <a:off x="3758142" y="135847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4082E54-7310-4E9E-8BCB-777DAADDEA88}"/>
                </a:ext>
              </a:extLst>
            </p:cNvPr>
            <p:cNvSpPr txBox="1"/>
            <p:nvPr/>
          </p:nvSpPr>
          <p:spPr>
            <a:xfrm>
              <a:off x="3873547" y="107457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DD63FF5-73DB-4993-81CE-0EC877395393}"/>
                </a:ext>
              </a:extLst>
            </p:cNvPr>
            <p:cNvSpPr txBox="1"/>
            <p:nvPr/>
          </p:nvSpPr>
          <p:spPr>
            <a:xfrm>
              <a:off x="3917695" y="99085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5784063-FBD1-42B7-8B2F-EFC790682C53}"/>
                </a:ext>
              </a:extLst>
            </p:cNvPr>
            <p:cNvSpPr txBox="1"/>
            <p:nvPr/>
          </p:nvSpPr>
          <p:spPr>
            <a:xfrm>
              <a:off x="4086985" y="132290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E50C510-115C-4437-ABD8-C73B758CEBE4}"/>
                </a:ext>
              </a:extLst>
            </p:cNvPr>
            <p:cNvSpPr txBox="1"/>
            <p:nvPr/>
          </p:nvSpPr>
          <p:spPr>
            <a:xfrm>
              <a:off x="4200927" y="102438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6F8F427-E055-4E90-8DE8-5335C3124469}"/>
                </a:ext>
              </a:extLst>
            </p:cNvPr>
            <p:cNvSpPr txBox="1"/>
            <p:nvPr/>
          </p:nvSpPr>
          <p:spPr>
            <a:xfrm>
              <a:off x="4256043" y="98871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7AF4FD1-2223-48A9-9DDD-4798F16A8AF7}"/>
                </a:ext>
              </a:extLst>
            </p:cNvPr>
            <p:cNvSpPr txBox="1"/>
            <p:nvPr/>
          </p:nvSpPr>
          <p:spPr>
            <a:xfrm>
              <a:off x="4418104" y="138418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2CB10B3-1D5C-4828-8C21-F8C460C618F7}"/>
                </a:ext>
              </a:extLst>
            </p:cNvPr>
            <p:cNvSpPr txBox="1"/>
            <p:nvPr/>
          </p:nvSpPr>
          <p:spPr>
            <a:xfrm>
              <a:off x="4580601" y="138094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BE2AB2A-878A-406B-B16B-212D17C9CC17}"/>
                </a:ext>
              </a:extLst>
            </p:cNvPr>
            <p:cNvSpPr txBox="1"/>
            <p:nvPr/>
          </p:nvSpPr>
          <p:spPr>
            <a:xfrm>
              <a:off x="4743030" y="134250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347182C-D5BC-4992-B1E7-5BDEEE277081}"/>
                </a:ext>
              </a:extLst>
            </p:cNvPr>
            <p:cNvSpPr txBox="1"/>
            <p:nvPr/>
          </p:nvSpPr>
          <p:spPr>
            <a:xfrm>
              <a:off x="5028372" y="141410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17CCF0D-20A4-48DB-BCA4-DE69ACB21120}"/>
                </a:ext>
              </a:extLst>
            </p:cNvPr>
            <p:cNvSpPr txBox="1"/>
            <p:nvPr/>
          </p:nvSpPr>
          <p:spPr>
            <a:xfrm>
              <a:off x="5077012" y="141059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11942A0-5D75-4F62-AF20-6E047ECB9CBF}"/>
                </a:ext>
              </a:extLst>
            </p:cNvPr>
            <p:cNvSpPr txBox="1"/>
            <p:nvPr/>
          </p:nvSpPr>
          <p:spPr>
            <a:xfrm>
              <a:off x="5193744" y="139140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A77A426-C9D8-4A56-B3AB-04D6CF4A1E42}"/>
                </a:ext>
              </a:extLst>
            </p:cNvPr>
            <p:cNvSpPr txBox="1"/>
            <p:nvPr/>
          </p:nvSpPr>
          <p:spPr>
            <a:xfrm>
              <a:off x="5239139" y="125170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7B7647C-2D0C-46F7-BD20-D764C30DE44F}"/>
                </a:ext>
              </a:extLst>
            </p:cNvPr>
            <p:cNvSpPr txBox="1"/>
            <p:nvPr/>
          </p:nvSpPr>
          <p:spPr>
            <a:xfrm>
              <a:off x="5518067" y="142030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66F0A82-FC96-490B-9645-7B096DF179CB}"/>
                </a:ext>
              </a:extLst>
            </p:cNvPr>
            <p:cNvSpPr txBox="1"/>
            <p:nvPr/>
          </p:nvSpPr>
          <p:spPr>
            <a:xfrm>
              <a:off x="5566703" y="136193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C4CE0BA-38C7-4277-8268-B696C1CCF82B}"/>
                </a:ext>
              </a:extLst>
            </p:cNvPr>
            <p:cNvSpPr txBox="1"/>
            <p:nvPr/>
          </p:nvSpPr>
          <p:spPr>
            <a:xfrm>
              <a:off x="6011001" y="125796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EC08E74-DCD7-49D4-846D-CD0A11434950}"/>
                </a:ext>
              </a:extLst>
            </p:cNvPr>
            <p:cNvSpPr txBox="1"/>
            <p:nvPr/>
          </p:nvSpPr>
          <p:spPr>
            <a:xfrm>
              <a:off x="6059633" y="120932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C095287-2A09-44CF-96BC-9F71EF6D8AF6}"/>
                </a:ext>
              </a:extLst>
            </p:cNvPr>
            <p:cNvSpPr txBox="1"/>
            <p:nvPr/>
          </p:nvSpPr>
          <p:spPr>
            <a:xfrm>
              <a:off x="6174439" y="113846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ABC9075-6645-41BF-B50B-04B1911A43B4}"/>
                </a:ext>
              </a:extLst>
            </p:cNvPr>
            <p:cNvSpPr txBox="1"/>
            <p:nvPr/>
          </p:nvSpPr>
          <p:spPr>
            <a:xfrm>
              <a:off x="6228072" y="105204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C684068-CCC6-4AC7-93DB-F309A74D4F6A}"/>
                </a:ext>
              </a:extLst>
            </p:cNvPr>
            <p:cNvSpPr txBox="1"/>
            <p:nvPr/>
          </p:nvSpPr>
          <p:spPr>
            <a:xfrm>
              <a:off x="6554194" y="129072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898EEA9-A307-40B4-8B7E-053D725A4EF7}"/>
                </a:ext>
              </a:extLst>
            </p:cNvPr>
            <p:cNvSpPr txBox="1"/>
            <p:nvPr/>
          </p:nvSpPr>
          <p:spPr>
            <a:xfrm>
              <a:off x="6667752" y="114798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089D8E4-7553-453E-A679-E6215E9C193D}"/>
                </a:ext>
              </a:extLst>
            </p:cNvPr>
            <p:cNvSpPr txBox="1"/>
            <p:nvPr/>
          </p:nvSpPr>
          <p:spPr>
            <a:xfrm>
              <a:off x="6719634" y="97287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B161158-9D76-4DF0-97BE-B79275552857}"/>
                </a:ext>
              </a:extLst>
            </p:cNvPr>
            <p:cNvSpPr txBox="1"/>
            <p:nvPr/>
          </p:nvSpPr>
          <p:spPr>
            <a:xfrm>
              <a:off x="7047127" y="143656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2432DBC-B9F7-4CFB-A0D3-0D4A3E4A5BD1}"/>
                </a:ext>
              </a:extLst>
            </p:cNvPr>
            <p:cNvSpPr txBox="1"/>
            <p:nvPr/>
          </p:nvSpPr>
          <p:spPr>
            <a:xfrm>
              <a:off x="7320131" y="125252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C639F42-C31B-47C8-8F5E-061D499BBBEC}"/>
                </a:ext>
              </a:extLst>
            </p:cNvPr>
            <p:cNvSpPr txBox="1"/>
            <p:nvPr/>
          </p:nvSpPr>
          <p:spPr>
            <a:xfrm>
              <a:off x="7375251" y="118118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9A07C90-42C1-436B-B69E-37C652972C1C}"/>
                </a:ext>
              </a:extLst>
            </p:cNvPr>
            <p:cNvSpPr txBox="1"/>
            <p:nvPr/>
          </p:nvSpPr>
          <p:spPr>
            <a:xfrm>
              <a:off x="7537380" y="133676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135DC1C-6B81-434A-9C17-CA14BD1B3D1E}"/>
                </a:ext>
              </a:extLst>
            </p:cNvPr>
            <p:cNvSpPr txBox="1"/>
            <p:nvPr/>
          </p:nvSpPr>
          <p:spPr>
            <a:xfrm>
              <a:off x="7699577" y="135946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AC34461-7220-4998-8A0A-868A558856F5}"/>
                </a:ext>
              </a:extLst>
            </p:cNvPr>
            <p:cNvSpPr txBox="1"/>
            <p:nvPr/>
          </p:nvSpPr>
          <p:spPr>
            <a:xfrm>
              <a:off x="7816238" y="85050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9634402-8E61-41CB-97A4-EA4DADA563DB}"/>
                </a:ext>
              </a:extLst>
            </p:cNvPr>
            <p:cNvSpPr txBox="1"/>
            <p:nvPr/>
          </p:nvSpPr>
          <p:spPr>
            <a:xfrm>
              <a:off x="7868115" y="89914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EEE1535-7DB7-48B3-98D7-2EA0EB7FAA9D}"/>
                </a:ext>
              </a:extLst>
            </p:cNvPr>
            <p:cNvSpPr txBox="1"/>
            <p:nvPr/>
          </p:nvSpPr>
          <p:spPr>
            <a:xfrm>
              <a:off x="7975189" y="128818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D1C921B-56F0-421A-84DB-4B170DBC6D8E}"/>
                </a:ext>
              </a:extLst>
            </p:cNvPr>
            <p:cNvSpPr txBox="1"/>
            <p:nvPr/>
          </p:nvSpPr>
          <p:spPr>
            <a:xfrm>
              <a:off x="8027066" y="122657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F105109-B569-4725-8F66-0B97E1D6A32A}"/>
                </a:ext>
              </a:extLst>
            </p:cNvPr>
            <p:cNvSpPr txBox="1"/>
            <p:nvPr/>
          </p:nvSpPr>
          <p:spPr>
            <a:xfrm>
              <a:off x="8150147" y="131107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DFE26F1-C7B6-448A-A933-1A4544E81293}"/>
                </a:ext>
              </a:extLst>
            </p:cNvPr>
            <p:cNvSpPr txBox="1"/>
            <p:nvPr/>
          </p:nvSpPr>
          <p:spPr>
            <a:xfrm>
              <a:off x="8202022" y="122352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2977C1A-A717-496C-AD17-73FEF31965A8}"/>
                </a:ext>
              </a:extLst>
            </p:cNvPr>
            <p:cNvSpPr txBox="1"/>
            <p:nvPr/>
          </p:nvSpPr>
          <p:spPr>
            <a:xfrm>
              <a:off x="8305983" y="125567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495B6FB-5BEC-430F-8A62-DB64BF885F41}"/>
                </a:ext>
              </a:extLst>
            </p:cNvPr>
            <p:cNvSpPr txBox="1"/>
            <p:nvPr/>
          </p:nvSpPr>
          <p:spPr>
            <a:xfrm>
              <a:off x="8354626" y="115515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1A9123A-F31C-4599-8A7E-1B4E4B96030E}"/>
                </a:ext>
              </a:extLst>
            </p:cNvPr>
            <p:cNvSpPr txBox="1"/>
            <p:nvPr/>
          </p:nvSpPr>
          <p:spPr>
            <a:xfrm>
              <a:off x="8471359" y="135620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55EE488-3167-4AE5-BF07-859A9DF800D8}"/>
                </a:ext>
              </a:extLst>
            </p:cNvPr>
            <p:cNvSpPr txBox="1"/>
            <p:nvPr/>
          </p:nvSpPr>
          <p:spPr>
            <a:xfrm>
              <a:off x="8636663" y="140489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F2CBE92-9755-44D9-8770-6FA4EC5CB9F0}"/>
                </a:ext>
              </a:extLst>
            </p:cNvPr>
            <p:cNvSpPr txBox="1"/>
            <p:nvPr/>
          </p:nvSpPr>
          <p:spPr>
            <a:xfrm>
              <a:off x="8682059" y="119738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88E43D2-5D74-48EC-B790-0D827BFB501C}"/>
                </a:ext>
              </a:extLst>
            </p:cNvPr>
            <p:cNvSpPr txBox="1"/>
            <p:nvPr/>
          </p:nvSpPr>
          <p:spPr>
            <a:xfrm>
              <a:off x="9016114" y="137890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/>
                <a:t>*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4E866BB1-8616-4066-A93F-F94E1560C048}"/>
                </a:ext>
              </a:extLst>
            </p:cNvPr>
            <p:cNvSpPr/>
            <p:nvPr/>
          </p:nvSpPr>
          <p:spPr>
            <a:xfrm>
              <a:off x="5293171" y="613096"/>
              <a:ext cx="783026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5F86B00-FFD0-4562-9D8D-4597148E5CDD}"/>
                </a:ext>
              </a:extLst>
            </p:cNvPr>
            <p:cNvSpPr/>
            <p:nvPr/>
          </p:nvSpPr>
          <p:spPr>
            <a:xfrm>
              <a:off x="5333081" y="1988874"/>
              <a:ext cx="783026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tor</a:t>
              </a:r>
            </a:p>
          </p:txBody>
        </p:sp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200A051F-9A39-4120-8698-B7C6AC2F54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4689" t="94130" r="43787" b="1025"/>
            <a:stretch/>
          </p:blipFill>
          <p:spPr>
            <a:xfrm>
              <a:off x="8354626" y="671212"/>
              <a:ext cx="815593" cy="161778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9975C8C-E49C-4470-B325-71BDF25353BE}"/>
                </a:ext>
              </a:extLst>
            </p:cNvPr>
            <p:cNvSpPr txBox="1"/>
            <p:nvPr/>
          </p:nvSpPr>
          <p:spPr>
            <a:xfrm>
              <a:off x="5340033" y="588085"/>
              <a:ext cx="7361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ection</a:t>
              </a: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28EB901A-4EB1-4215-9698-7570F6EE36DA}"/>
              </a:ext>
            </a:extLst>
          </p:cNvPr>
          <p:cNvSpPr txBox="1"/>
          <p:nvPr/>
        </p:nvSpPr>
        <p:spPr>
          <a:xfrm>
            <a:off x="2067697" y="5011825"/>
            <a:ext cx="7546086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/>
              <a:t>Figure S3 -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infection of explants from healthy donors or severe asthmatics and subsequent PD-1 blockade, on mediator secretion into tissue conditioned culture medium, compared to mock-infected controls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 Bronchial lung tissue explants from healthy and asthmatic donors were infected with influenza either with prior exposure to PD-1 blocking monoclonal antibodies or control isotype-matched antibodies,, and then incubated in the presence of these antibodies for a further 24 h. 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ssue-conditioned cell culture media were analysed by multiplexed immunoassay for cytokines/chemokines.  A) The effect of infection was compared using baseline control Mab-exposed tissues. B) The fold change following exposure to control/PD-1 blockade antibodies was measured to determine the effect of PD-1 blockade.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shown are log10 median fold change values compared to mock-infected controls.  N=10 per group.  Data are medians +/- IQR, compared using Wilcoxon matched signed rank tests. *=p&lt;0.05, unadjusted p values. </a:t>
            </a:r>
            <a:endParaRPr lang="en-GB" sz="1200" dirty="0"/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998CD525-FB65-4C77-957D-C4A0E3DDB7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0248" b="1"/>
          <a:stretch/>
        </p:blipFill>
        <p:spPr>
          <a:xfrm>
            <a:off x="2131445" y="3323964"/>
            <a:ext cx="7077003" cy="1661028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15893A96-376A-4FE3-AE4E-7FDA665977E6}"/>
              </a:ext>
            </a:extLst>
          </p:cNvPr>
          <p:cNvSpPr txBox="1"/>
          <p:nvPr/>
        </p:nvSpPr>
        <p:spPr>
          <a:xfrm>
            <a:off x="3281475" y="357148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*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2EA84B3-BEE2-4938-9AFA-EB9AA5DF8557}"/>
              </a:ext>
            </a:extLst>
          </p:cNvPr>
          <p:cNvSpPr txBox="1"/>
          <p:nvPr/>
        </p:nvSpPr>
        <p:spPr>
          <a:xfrm>
            <a:off x="6418134" y="360410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*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395847A-199C-49BA-ADEF-9341455DA173}"/>
              </a:ext>
            </a:extLst>
          </p:cNvPr>
          <p:cNvSpPr txBox="1"/>
          <p:nvPr/>
        </p:nvSpPr>
        <p:spPr>
          <a:xfrm>
            <a:off x="8067482" y="35927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*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7B38D5DD-9607-4B5D-8B02-99D0C5CC8BA5}"/>
              </a:ext>
            </a:extLst>
          </p:cNvPr>
          <p:cNvSpPr/>
          <p:nvPr/>
        </p:nvSpPr>
        <p:spPr>
          <a:xfrm>
            <a:off x="5278433" y="3377265"/>
            <a:ext cx="783026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44D89A6A-4B6D-48DE-8E19-9872FECCC4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689" t="94130" r="43787" b="1025"/>
          <a:stretch/>
        </p:blipFill>
        <p:spPr>
          <a:xfrm>
            <a:off x="8303444" y="3404098"/>
            <a:ext cx="815593" cy="161778"/>
          </a:xfrm>
          <a:prstGeom prst="rect">
            <a:avLst/>
          </a:prstGeom>
        </p:spPr>
      </p:pic>
      <p:sp>
        <p:nvSpPr>
          <p:cNvPr id="67" name="Rectangle 66">
            <a:extLst>
              <a:ext uri="{FF2B5EF4-FFF2-40B4-BE49-F238E27FC236}">
                <a16:creationId xmlns:a16="http://schemas.microsoft.com/office/drawing/2014/main" id="{06CCBEDF-DA86-412B-93A7-0532E59DF9DF}"/>
              </a:ext>
            </a:extLst>
          </p:cNvPr>
          <p:cNvSpPr/>
          <p:nvPr/>
        </p:nvSpPr>
        <p:spPr>
          <a:xfrm>
            <a:off x="4465618" y="4715839"/>
            <a:ext cx="2328202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tor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4598412-F536-4FFD-A443-C13869236E23}"/>
              </a:ext>
            </a:extLst>
          </p:cNvPr>
          <p:cNvSpPr txBox="1"/>
          <p:nvPr/>
        </p:nvSpPr>
        <p:spPr>
          <a:xfrm>
            <a:off x="5117551" y="3315710"/>
            <a:ext cx="1104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 blockade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6BA3F2A-372E-4B7F-9ABA-A9C6472698F7}"/>
              </a:ext>
            </a:extLst>
          </p:cNvPr>
          <p:cNvSpPr txBox="1"/>
          <p:nvPr/>
        </p:nvSpPr>
        <p:spPr>
          <a:xfrm>
            <a:off x="1758739" y="1167744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EE1056C-F2F8-4C98-9EB8-695673F372DD}"/>
              </a:ext>
            </a:extLst>
          </p:cNvPr>
          <p:cNvSpPr txBox="1"/>
          <p:nvPr/>
        </p:nvSpPr>
        <p:spPr>
          <a:xfrm>
            <a:off x="1753187" y="3305441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521863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227</Words>
  <Application>Microsoft Office PowerPoint</Application>
  <PresentationFormat>Widescreen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jamin Nicholas</dc:creator>
  <cp:lastModifiedBy>Benjamin Nicholas</cp:lastModifiedBy>
  <cp:revision>6</cp:revision>
  <dcterms:created xsi:type="dcterms:W3CDTF">2022-09-07T16:59:50Z</dcterms:created>
  <dcterms:modified xsi:type="dcterms:W3CDTF">2022-09-07T19:44:02Z</dcterms:modified>
</cp:coreProperties>
</file>